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8" autoAdjust="0"/>
    <p:restoredTop sz="94660"/>
  </p:normalViewPr>
  <p:slideViewPr>
    <p:cSldViewPr snapToGrid="0">
      <p:cViewPr varScale="1">
        <p:scale>
          <a:sx n="64" d="100"/>
          <a:sy n="64" d="100"/>
        </p:scale>
        <p:origin x="74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7863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6821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3359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441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8252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1891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6249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257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2042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7232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4809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4434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>
            <a:extLst>
              <a:ext uri="{FF2B5EF4-FFF2-40B4-BE49-F238E27FC236}">
                <a16:creationId xmlns:a16="http://schemas.microsoft.com/office/drawing/2014/main" id="{86B5444D-F320-44DC-817E-0BB3BBE426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3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0" y="96822"/>
            <a:ext cx="6679101" cy="6325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3FB03D5-3617-417D-86D4-2BCE724AE4D0}"/>
              </a:ext>
            </a:extLst>
          </p:cNvPr>
          <p:cNvSpPr txBox="1"/>
          <p:nvPr/>
        </p:nvSpPr>
        <p:spPr>
          <a:xfrm>
            <a:off x="6708913" y="4134678"/>
            <a:ext cx="49993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846C193-8D10-419C-AAE5-04DEDD9B3F9A}"/>
              </a:ext>
            </a:extLst>
          </p:cNvPr>
          <p:cNvSpPr txBox="1"/>
          <p:nvPr/>
        </p:nvSpPr>
        <p:spPr>
          <a:xfrm>
            <a:off x="641130" y="6421822"/>
            <a:ext cx="6190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ultivars 1-18 each represented by 4 biological repetition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17C1C8B-4B93-4F03-B87F-E5C80A658E93}"/>
              </a:ext>
            </a:extLst>
          </p:cNvPr>
          <p:cNvSpPr txBox="1"/>
          <p:nvPr/>
        </p:nvSpPr>
        <p:spPr>
          <a:xfrm>
            <a:off x="5917101" y="1728394"/>
            <a:ext cx="1240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Z-score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807B509-9B68-4007-BAA5-13BADB451B71}"/>
              </a:ext>
            </a:extLst>
          </p:cNvPr>
          <p:cNvSpPr/>
          <p:nvPr/>
        </p:nvSpPr>
        <p:spPr>
          <a:xfrm>
            <a:off x="6432331" y="4946986"/>
            <a:ext cx="5239182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upplemental Figure 1.</a:t>
            </a:r>
            <a:r>
              <a:rPr lang="en-GB" dirty="0"/>
              <a:t> Hierarchical clustering of the 1,941 proteins identified in the  18 cultivars (four replicates each). Colours show log₂ protein intensity normalized by z‑score (blue: low abundance; red: high abundance).</a:t>
            </a:r>
          </a:p>
        </p:txBody>
      </p:sp>
    </p:spTree>
    <p:extLst>
      <p:ext uri="{BB962C8B-B14F-4D97-AF65-F5344CB8AC3E}">
        <p14:creationId xmlns:p14="http://schemas.microsoft.com/office/powerpoint/2010/main" val="1725247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59</TotalTime>
  <Words>51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pdate – hypoallergenic hazelnuts.  17 07 2024</dc:title>
  <dc:creator>Barbara Karpinska (Biosciences)</dc:creator>
  <cp:lastModifiedBy>Christine Foyer (Biosciences)</cp:lastModifiedBy>
  <cp:revision>124</cp:revision>
  <dcterms:created xsi:type="dcterms:W3CDTF">2024-07-16T19:44:14Z</dcterms:created>
  <dcterms:modified xsi:type="dcterms:W3CDTF">2025-09-09T04:03:30Z</dcterms:modified>
</cp:coreProperties>
</file>